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6C82C8C-2783-4A16-B72F-E5D4CC13F9E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828388-9FFA-4FE2-BA9F-7453241094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597A4A0-21DC-42AE-B522-CA1C02E79A6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6FC2172-B86B-4173-9CF5-6D6865BB194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6945E34-EAB9-475B-8F80-6227E6F37E3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D02052-4255-4B8B-AA2F-71FF526D3F5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FA7179B-9F7C-43EC-A55A-FD9EC49CC90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FF8CD71-A1A0-45DB-8CD2-B6250334329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0613248-D373-4861-98D2-4DDA6B6EAA7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B90007-01CF-4D1F-92E0-9E29FDF88CF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07E28B5-888B-439F-85A3-394EEE74F1B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AD35194-BF37-43EA-B457-1530E3B59D4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C7EF62F-B1BF-4D00-B8F8-ABBEB90413C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 Box 10"/>
          <p:cNvSpPr/>
          <p:nvPr/>
        </p:nvSpPr>
        <p:spPr>
          <a:xfrm>
            <a:off x="1403280" y="404640"/>
            <a:ext cx="19447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R   PR    TL   PL   BL   BP   </a:t>
            </a:r>
            <a:endParaRPr b="0" lang="en-US" sz="1200" spc="-1" strike="noStrike">
              <a:solidFill>
                <a:srgbClr val="000000"/>
              </a:solidFill>
              <a:latin typeface="Arial"/>
            </a:endParaRPr>
          </a:p>
        </p:txBody>
      </p:sp>
      <p:grpSp>
        <p:nvGrpSpPr>
          <p:cNvPr id="42" name="Group 17"/>
          <p:cNvGrpSpPr/>
          <p:nvPr/>
        </p:nvGrpSpPr>
        <p:grpSpPr>
          <a:xfrm>
            <a:off x="1476360" y="620640"/>
            <a:ext cx="1800360" cy="5729400"/>
            <a:chOff x="1476360" y="620640"/>
            <a:chExt cx="1800360" cy="5729400"/>
          </a:xfrm>
        </p:grpSpPr>
        <p:pic>
          <p:nvPicPr>
            <p:cNvPr id="43" name="Picture 3" descr="All DEGs"/>
            <p:cNvPicPr/>
            <p:nvPr/>
          </p:nvPicPr>
          <p:blipFill>
            <a:blip r:embed="rId1"/>
            <a:srcRect l="30979" t="30669" r="28725" b="0"/>
            <a:stretch/>
          </p:blipFill>
          <p:spPr>
            <a:xfrm>
              <a:off x="1476360" y="620640"/>
              <a:ext cx="1800360" cy="5060880"/>
            </a:xfrm>
            <a:prstGeom prst="rect">
              <a:avLst/>
            </a:prstGeom>
            <a:ln w="0">
              <a:noFill/>
            </a:ln>
          </p:spPr>
        </p:pic>
        <p:grpSp>
          <p:nvGrpSpPr>
            <p:cNvPr id="44" name="Group 16"/>
            <p:cNvGrpSpPr/>
            <p:nvPr/>
          </p:nvGrpSpPr>
          <p:grpSpPr>
            <a:xfrm>
              <a:off x="1547640" y="5891040"/>
              <a:ext cx="1582920" cy="459000"/>
              <a:chOff x="1547640" y="5891040"/>
              <a:chExt cx="1582920" cy="459000"/>
            </a:xfrm>
          </p:grpSpPr>
          <p:pic>
            <p:nvPicPr>
              <p:cNvPr id="45" name="Picture 5" descr="Leave Specific DEG"/>
              <p:cNvPicPr/>
              <p:nvPr/>
            </p:nvPicPr>
            <p:blipFill>
              <a:blip r:embed="rId2"/>
              <a:srcRect l="0" t="0" r="62870" b="98323"/>
              <a:stretch/>
            </p:blipFill>
            <p:spPr>
              <a:xfrm>
                <a:off x="1874880" y="5891040"/>
                <a:ext cx="965160" cy="138240"/>
              </a:xfrm>
              <a:prstGeom prst="rect">
                <a:avLst/>
              </a:prstGeom>
              <a:ln w="0">
                <a:noFill/>
              </a:ln>
            </p:spPr>
          </p:pic>
          <p:sp>
            <p:nvSpPr>
              <p:cNvPr id="46" name="Text Box 6"/>
              <p:cNvSpPr/>
              <p:nvPr/>
            </p:nvSpPr>
            <p:spPr>
              <a:xfrm>
                <a:off x="2214720" y="5961240"/>
                <a:ext cx="3412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47" name="Text Box 7"/>
              <p:cNvSpPr/>
              <p:nvPr/>
            </p:nvSpPr>
            <p:spPr>
              <a:xfrm>
                <a:off x="1547640" y="5950080"/>
                <a:ext cx="6480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6</a:t>
                </a:r>
                <a:endParaRPr b="0" lang="en-US" sz="1000" spc="-1" strike="noStrike">
                  <a:solidFill>
                    <a:srgbClr val="000000"/>
                  </a:solidFill>
                  <a:latin typeface="Arial"/>
                </a:endParaRPr>
              </a:p>
            </p:txBody>
          </p:sp>
          <p:sp>
            <p:nvSpPr>
              <p:cNvPr id="48" name="Text Box 8"/>
              <p:cNvSpPr/>
              <p:nvPr/>
            </p:nvSpPr>
            <p:spPr>
              <a:xfrm>
                <a:off x="2612880" y="5961240"/>
                <a:ext cx="3412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a:t>
                </a:r>
                <a:endParaRPr b="0" lang="en-US" sz="1000" spc="-1" strike="noStrike">
                  <a:solidFill>
                    <a:srgbClr val="000000"/>
                  </a:solidFill>
                  <a:latin typeface="Arial"/>
                </a:endParaRPr>
              </a:p>
            </p:txBody>
          </p:sp>
          <p:sp>
            <p:nvSpPr>
              <p:cNvPr id="49" name="Text Box 12"/>
              <p:cNvSpPr/>
              <p:nvPr/>
            </p:nvSpPr>
            <p:spPr>
              <a:xfrm>
                <a:off x="1979640" y="6165720"/>
                <a:ext cx="863640" cy="1843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Text Box 13"/>
              <p:cNvSpPr/>
              <p:nvPr/>
            </p:nvSpPr>
            <p:spPr>
              <a:xfrm>
                <a:off x="2050920" y="6093000"/>
                <a:ext cx="107964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Log(Ratio)</a:t>
                </a:r>
                <a:endParaRPr b="0" lang="en-US" sz="900" spc="-1" strike="noStrike">
                  <a:solidFill>
                    <a:srgbClr val="000000"/>
                  </a:solidFill>
                  <a:latin typeface="Arial"/>
                </a:endParaRPr>
              </a:p>
            </p:txBody>
          </p:sp>
        </p:grpSp>
      </p:grpSp>
      <p:sp>
        <p:nvSpPr>
          <p:cNvPr id="51" name="Text Box 9"/>
          <p:cNvSpPr/>
          <p:nvPr/>
        </p:nvSpPr>
        <p:spPr>
          <a:xfrm>
            <a:off x="3780000" y="620640"/>
            <a:ext cx="4032000" cy="222516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rPr>
              <a:t>Additional file 3</a:t>
            </a:r>
            <a:r>
              <a:rPr b="0" lang="en-US" sz="1400" spc="-1" strike="noStrike">
                <a:solidFill>
                  <a:srgbClr val="000000"/>
                </a:solidFill>
                <a:latin typeface="Times New Roman"/>
              </a:rPr>
              <a:t>. Hierarchical cluster analysis of six tissue types (columns) and all DEGs under drought stress (rows). TL, PL and BL indicate leaf at tillering stage (TL), panicle elongation stage (PL) and booting stage (BL) respectively; TR and PR indicate roots at tillering stage (TR) and panicle elongation stage (PR); BP is the young panicle at booting stage. The median ratio (drought stressed/control) is log2 transformed and subjected to complete linkage hierarchical clustering.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2-11T08:02:04Z</dcterms:created>
  <dc:creator>Binying Fu</dc:creator>
  <dc:description/>
  <dc:language>en-US</dc:language>
  <cp:lastModifiedBy>Binying Fu</cp:lastModifiedBy>
  <dcterms:modified xsi:type="dcterms:W3CDTF">2011-03-09T06:10:20Z</dcterms:modified>
  <cp:revision>10</cp:revision>
  <dc:subject/>
  <dc:title>幻灯片 1</dc:title>
</cp:coreProperties>
</file>